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1" r:id="rId3"/>
    <p:sldId id="266" r:id="rId4"/>
    <p:sldId id="265" r:id="rId5"/>
    <p:sldId id="263" r:id="rId6"/>
    <p:sldId id="262" r:id="rId7"/>
    <p:sldId id="260" r:id="rId8"/>
    <p:sldId id="264" r:id="rId9"/>
    <p:sldId id="258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149" autoAdjust="0"/>
  </p:normalViewPr>
  <p:slideViewPr>
    <p:cSldViewPr snapToGrid="0" snapToObjects="1">
      <p:cViewPr>
        <p:scale>
          <a:sx n="125" d="100"/>
          <a:sy n="125" d="100"/>
        </p:scale>
        <p:origin x="-80" y="2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830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239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865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262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519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234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826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857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607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683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136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8406D2-ABB9-6D46-966F-A8A75D53A57A}" type="datetimeFigureOut">
              <a:rPr lang="en-US" smtClean="0"/>
              <a:t>21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CFDEE3-C4AB-B447-9B4A-A5A4582B4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157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5409782"/>
              </p:ext>
            </p:extLst>
          </p:nvPr>
        </p:nvGraphicFramePr>
        <p:xfrm>
          <a:off x="1806090" y="2196682"/>
          <a:ext cx="5422193" cy="227630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79382"/>
                <a:gridCol w="900572"/>
                <a:gridCol w="806762"/>
                <a:gridCol w="825524"/>
                <a:gridCol w="909953"/>
              </a:tblGrid>
              <a:tr h="252923"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Marine-RM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Marine-TM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Human-Oral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Human-Stool</a:t>
                      </a:r>
                      <a:endParaRPr lang="en-US" sz="800" b="1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2923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/>
                          <a:cs typeface="Arial"/>
                        </a:rPr>
                        <a:t># Genomes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378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344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209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479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2923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/>
                          <a:cs typeface="Arial"/>
                        </a:rPr>
                        <a:t>#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Species*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363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308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140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338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2923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/>
                          <a:cs typeface="Arial"/>
                        </a:rPr>
                        <a:t>#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Genera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153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172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59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effectLst/>
                          <a:latin typeface="Arial"/>
                          <a:cs typeface="Arial"/>
                        </a:rPr>
                        <a:t>106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2923"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# of metagenomes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50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50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50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50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2923"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# PE reads</a:t>
                      </a:r>
                      <a:r>
                        <a:rPr lang="en-US" sz="800" dirty="0" smtClean="0">
                          <a:effectLst/>
                          <a:latin typeface="Arial"/>
                          <a:cs typeface="Arial"/>
                        </a:rPr>
                        <a:t>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600,000,000</a:t>
                      </a:r>
                      <a:r>
                        <a:rPr lang="en-US" sz="800" dirty="0" smtClean="0">
                          <a:effectLst/>
                          <a:latin typeface="Arial"/>
                          <a:cs typeface="Arial"/>
                        </a:rPr>
                        <a:t>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600,000,000</a:t>
                      </a:r>
                      <a:r>
                        <a:rPr lang="en-US" sz="800" dirty="0" smtClean="0">
                          <a:effectLst/>
                          <a:latin typeface="Arial"/>
                          <a:cs typeface="Arial"/>
                        </a:rPr>
                        <a:t>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600,000,000</a:t>
                      </a:r>
                      <a:r>
                        <a:rPr lang="en-US" sz="800" dirty="0" smtClean="0">
                          <a:effectLst/>
                          <a:latin typeface="Arial"/>
                          <a:cs typeface="Arial"/>
                        </a:rPr>
                        <a:t>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600,000,000</a:t>
                      </a:r>
                      <a:r>
                        <a:rPr lang="en-US" sz="800" dirty="0" smtClean="0">
                          <a:effectLst/>
                          <a:latin typeface="Arial"/>
                          <a:cs typeface="Arial"/>
                        </a:rPr>
                        <a:t>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2923">
                <a:tc>
                  <a:txBody>
                    <a:bodyPr/>
                    <a:lstStyle/>
                    <a:p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# HQ sequences</a:t>
                      </a:r>
                      <a:r>
                        <a:rPr lang="en-US" sz="800" dirty="0" smtClean="0">
                          <a:effectLst/>
                          <a:latin typeface="Arial"/>
                          <a:cs typeface="Arial"/>
                        </a:rPr>
                        <a:t> 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00,009,308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00,009,384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00,010,948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00,017,357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292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# of predicted ORFs 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88,385,700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90,575,789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87,083,27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86,809,051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292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# of ORFs annotated with a BGC domain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5,068,930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5,607,322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,407,877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,249,576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806090" y="1745276"/>
            <a:ext cx="5422193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800" dirty="0" smtClean="0">
                <a:latin typeface="Arial"/>
                <a:cs typeface="Arial"/>
              </a:rPr>
              <a:t>Supplementary Table </a:t>
            </a:r>
            <a:r>
              <a:rPr lang="en-US" sz="800" dirty="0">
                <a:latin typeface="Arial"/>
                <a:cs typeface="Arial"/>
              </a:rPr>
              <a:t>1</a:t>
            </a:r>
            <a:r>
              <a:rPr lang="en-US" sz="800" dirty="0" smtClean="0">
                <a:latin typeface="Arial"/>
                <a:cs typeface="Arial"/>
              </a:rPr>
              <a:t>. Details of the Marine-RM, Marine-TM, Human-Oral, and Human-Stool simulated metagenomic datasets.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06090" y="4488583"/>
            <a:ext cx="50603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Different </a:t>
            </a:r>
            <a:r>
              <a:rPr lang="en-US" sz="800" dirty="0">
                <a:latin typeface="Arial"/>
                <a:cs typeface="Arial"/>
              </a:rPr>
              <a:t>strains from the same genus without a species name (i.e., sp.) were counted as different species. </a:t>
            </a:r>
          </a:p>
        </p:txBody>
      </p:sp>
    </p:spTree>
    <p:extLst>
      <p:ext uri="{BB962C8B-B14F-4D97-AF65-F5344CB8AC3E}">
        <p14:creationId xmlns:p14="http://schemas.microsoft.com/office/powerpoint/2010/main" val="1053890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9908937"/>
              </p:ext>
            </p:extLst>
          </p:nvPr>
        </p:nvGraphicFramePr>
        <p:xfrm>
          <a:off x="1041022" y="1206982"/>
          <a:ext cx="6756397" cy="454188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71133"/>
                <a:gridCol w="1066800"/>
                <a:gridCol w="800332"/>
                <a:gridCol w="1006044"/>
                <a:gridCol w="1006044"/>
                <a:gridCol w="1006044"/>
              </a:tblGrid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Compariso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Pairwi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-value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baseline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tatistic</a:t>
                      </a:r>
                      <a:endParaRPr lang="en-US" sz="800" b="1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BGC domain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-based </a:t>
                      </a:r>
                      <a:r>
                        <a:rPr lang="en-US" sz="800" b="0" baseline="0" dirty="0" err="1" smtClean="0">
                          <a:latin typeface="Arial"/>
                          <a:cs typeface="Arial"/>
                        </a:rPr>
                        <a:t>PCoA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irst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xis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SRF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DCM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No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5 (63 + 42)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91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79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BGC domain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-based </a:t>
                      </a:r>
                      <a:r>
                        <a:rPr lang="en-US" sz="800" b="0" baseline="0" dirty="0" err="1" smtClean="0">
                          <a:latin typeface="Arial"/>
                          <a:cs typeface="Arial"/>
                        </a:rPr>
                        <a:t>PCoA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irst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xis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SRF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MES</a:t>
                      </a:r>
                      <a:endParaRPr lang="en-US" sz="80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No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93 (63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+ 30)</a:t>
                      </a:r>
                      <a:endParaRPr lang="en-US" sz="80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8.889e-1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88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BGC domain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-based </a:t>
                      </a:r>
                      <a:r>
                        <a:rPr lang="en-US" sz="800" b="0" baseline="0" dirty="0" err="1" smtClean="0">
                          <a:latin typeface="Arial"/>
                          <a:cs typeface="Arial"/>
                        </a:rPr>
                        <a:t>PCoA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irst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xis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DCM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M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No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72 (42 + 30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&lt; 2.2e-1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7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BGC class-based </a:t>
                      </a:r>
                      <a:r>
                        <a:rPr lang="en-US" sz="800" b="0" baseline="0" dirty="0" err="1" smtClean="0">
                          <a:latin typeface="Arial"/>
                          <a:cs typeface="Arial"/>
                        </a:rPr>
                        <a:t>PCoA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irst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xis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SRF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DCM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No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5 (63 + 42)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404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76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BGC class-based </a:t>
                      </a:r>
                      <a:r>
                        <a:rPr lang="en-US" sz="800" b="0" baseline="0" dirty="0" err="1" smtClean="0">
                          <a:latin typeface="Arial"/>
                          <a:cs typeface="Arial"/>
                        </a:rPr>
                        <a:t>PCoA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irst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xis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SRF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MES</a:t>
                      </a:r>
                      <a:endParaRPr lang="en-US" sz="80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No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93 (63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+ 30)</a:t>
                      </a:r>
                      <a:endParaRPr lang="en-US" sz="80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.538e-1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88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BGC class-based </a:t>
                      </a:r>
                      <a:r>
                        <a:rPr lang="en-US" sz="800" b="0" baseline="0" dirty="0" err="1" smtClean="0">
                          <a:latin typeface="Arial"/>
                          <a:cs typeface="Arial"/>
                        </a:rPr>
                        <a:t>PCoA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irst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xis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DCM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M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No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72 (42 + 30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&lt; 2.2e-1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2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SRF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DCM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42 (21 + 21)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.387e-0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SRF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MES</a:t>
                      </a:r>
                      <a:endParaRPr lang="en-US" sz="80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42 (21 + 21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.537e-07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DCM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MES</a:t>
                      </a:r>
                      <a:endParaRPr lang="en-US" sz="80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42 (21 + 21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0292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SRF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DCM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42 (21 + 21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17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27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SRF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MES</a:t>
                      </a:r>
                      <a:endParaRPr lang="en-US" sz="80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42 (21 + 21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.907e-0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DCM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MES</a:t>
                      </a:r>
                      <a:endParaRPr lang="en-US" sz="80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42 (21 + 21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0353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2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041022" y="386244"/>
            <a:ext cx="6756397" cy="8207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800" dirty="0">
                <a:latin typeface="Arial"/>
                <a:cs typeface="Arial"/>
              </a:rPr>
              <a:t>Supplementary Table </a:t>
            </a:r>
            <a:r>
              <a:rPr lang="en-US" sz="800" dirty="0" smtClean="0">
                <a:latin typeface="Arial"/>
                <a:cs typeface="Arial"/>
              </a:rPr>
              <a:t>2. </a:t>
            </a:r>
            <a:r>
              <a:rPr lang="en-US" sz="800" dirty="0">
                <a:latin typeface="Arial"/>
                <a:cs typeface="Arial"/>
              </a:rPr>
              <a:t>Wilcoxon rank sum tests </a:t>
            </a:r>
            <a:r>
              <a:rPr lang="en-US" sz="800" dirty="0" smtClean="0">
                <a:latin typeface="Arial"/>
                <a:cs typeface="Arial"/>
              </a:rPr>
              <a:t>(two-sided) performed </a:t>
            </a:r>
            <a:r>
              <a:rPr lang="en-US" sz="800" dirty="0">
                <a:latin typeface="Arial"/>
                <a:cs typeface="Arial"/>
              </a:rPr>
              <a:t>to evaluate the significance of the differentiation between TARA Oceans metagenomes of the different water layers according to their ordination in the first axis of the Principal Coordinate Analyses (</a:t>
            </a:r>
            <a:r>
              <a:rPr lang="en-US" sz="800" dirty="0" err="1">
                <a:latin typeface="Arial"/>
                <a:cs typeface="Arial"/>
              </a:rPr>
              <a:t>PCoAs</a:t>
            </a:r>
            <a:r>
              <a:rPr lang="en-US" sz="800" dirty="0">
                <a:latin typeface="Arial"/>
                <a:cs typeface="Arial"/>
              </a:rPr>
              <a:t>), and the Operational Domain Unit (ODU) diversity estimates. SRF, DCM, and MES correspond to surface, deep chlorophyll maximum and mesopelagic water layers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1055708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33468" y="509174"/>
            <a:ext cx="6263352" cy="1005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800" dirty="0">
                <a:latin typeface="Arial"/>
                <a:cs typeface="Arial"/>
              </a:rPr>
              <a:t>Supplementary Table 3. </a:t>
            </a:r>
            <a:r>
              <a:rPr lang="en-US" sz="800" dirty="0" err="1">
                <a:latin typeface="Arial"/>
                <a:cs typeface="Arial"/>
              </a:rPr>
              <a:t>Permutational</a:t>
            </a:r>
            <a:r>
              <a:rPr lang="en-US" sz="800" dirty="0">
                <a:latin typeface="Arial"/>
                <a:cs typeface="Arial"/>
              </a:rPr>
              <a:t> Multivariate Analysis of Variance (PERMANOVA) to test if the BGC class composition predicted in TARA Oceans metagenomes differs between water layers. The PERMANOVA was performed on the Bray-Curtis dissimilarity matrix obtained from the BGC class relative abundance profiles, for a balanced subset of 63 metagenomes (i.e., 21 from each water layer). P-values were adjusted with the </a:t>
            </a:r>
            <a:r>
              <a:rPr lang="en-US" sz="800" dirty="0" err="1">
                <a:latin typeface="Arial"/>
                <a:cs typeface="Arial"/>
              </a:rPr>
              <a:t>Bonferroni</a:t>
            </a:r>
            <a:r>
              <a:rPr lang="en-US" sz="800" dirty="0">
                <a:latin typeface="Arial"/>
                <a:cs typeface="Arial"/>
              </a:rPr>
              <a:t> correction for multiple comparisons. SRF, DCM, and MES correspond to surface, deep chlorophyll maximum and mesopelagic water layers, respectively.</a:t>
            </a:r>
            <a:endParaRPr lang="en-US" sz="800" dirty="0" smtClean="0">
              <a:latin typeface="Arial"/>
              <a:cs typeface="Arial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7478014"/>
              </p:ext>
            </p:extLst>
          </p:nvPr>
        </p:nvGraphicFramePr>
        <p:xfrm>
          <a:off x="833468" y="1514578"/>
          <a:ext cx="6263352" cy="186947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62823"/>
                <a:gridCol w="648492"/>
                <a:gridCol w="790728"/>
                <a:gridCol w="711655"/>
                <a:gridCol w="711655"/>
                <a:gridCol w="958334"/>
                <a:gridCol w="473484"/>
                <a:gridCol w="706181"/>
              </a:tblGrid>
              <a:tr h="363958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Compariso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-value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-value adjusted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Pseudo-F statistic</a:t>
                      </a:r>
                      <a:endParaRPr lang="en-US" sz="800" b="1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R</a:t>
                      </a:r>
                      <a:r>
                        <a:rPr lang="en-US" sz="800" b="1" baseline="300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# of</a:t>
                      </a:r>
                      <a:r>
                        <a:rPr lang="en-US" sz="800" b="1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perm.</a:t>
                      </a:r>
                      <a:endParaRPr lang="en-US" sz="800" b="1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N</a:t>
                      </a:r>
                      <a:endParaRPr lang="en-US" sz="800" b="1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Degrees</a:t>
                      </a:r>
                      <a:r>
                        <a:rPr lang="en-US" sz="800" b="1" baseline="0" dirty="0" smtClean="0">
                          <a:latin typeface="Arial"/>
                          <a:cs typeface="Arial"/>
                        </a:rPr>
                        <a:t> of freedom</a:t>
                      </a:r>
                      <a:endParaRPr lang="en-US" sz="800" b="1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395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Al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water layer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0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NA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79.6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72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2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1364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SRF vs.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DCM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7 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2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3.6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8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42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395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SRF vs.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M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 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53.12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79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42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395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DCM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vs. M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78.0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66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42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156925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1234681"/>
              </p:ext>
            </p:extLst>
          </p:nvPr>
        </p:nvGraphicFramePr>
        <p:xfrm>
          <a:off x="1041022" y="1206982"/>
          <a:ext cx="6062511" cy="492137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108578"/>
                <a:gridCol w="745067"/>
                <a:gridCol w="745066"/>
                <a:gridCol w="690770"/>
                <a:gridCol w="528430"/>
                <a:gridCol w="1244600"/>
              </a:tblGrid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Compariso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earson’s r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-value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baseline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tatistic</a:t>
                      </a:r>
                      <a:endParaRPr lang="en-US" sz="800" b="1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N</a:t>
                      </a:r>
                      <a:endParaRPr lang="en-US" sz="800" b="1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Degrees</a:t>
                      </a:r>
                      <a:r>
                        <a:rPr lang="en-US" sz="800" b="1" baseline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of freedom</a:t>
                      </a:r>
                      <a:endParaRPr lang="en-US" sz="800" b="1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BGC domain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-based </a:t>
                      </a:r>
                      <a:r>
                        <a:rPr lang="en-US" sz="800" b="0" baseline="0" dirty="0" err="1" smtClean="0">
                          <a:latin typeface="Arial"/>
                          <a:cs typeface="Arial"/>
                        </a:rPr>
                        <a:t>PCoA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irst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xis </a:t>
                      </a:r>
                      <a:br>
                        <a:rPr lang="en-US" sz="800" b="0" baseline="0" dirty="0" smtClean="0">
                          <a:latin typeface="Arial"/>
                          <a:cs typeface="Arial"/>
                        </a:rPr>
                      </a:b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temperature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-0.7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&lt; 2.2e-1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-12.28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3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13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BGC class-based </a:t>
                      </a:r>
                      <a:r>
                        <a:rPr lang="en-US" sz="800" b="0" baseline="0" dirty="0" err="1" smtClean="0">
                          <a:latin typeface="Arial"/>
                          <a:cs typeface="Arial"/>
                        </a:rPr>
                        <a:t>PCoA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irst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xis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temperature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-0.7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&lt; 2.2e-1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-12.22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3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3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taxonomic richne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 0.8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.155e-1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.26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taxonomic richne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7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3.802e-1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.94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taxonomic divers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6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8.688e-0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.71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taxonomic divers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4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7.008e-0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4.28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unctional richne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87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.979e-1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3.41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unctional richne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7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2.508e-12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8.83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unctional divers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5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.747e-0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4.94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functional divers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5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800" dirty="0" smtClean="0">
                          <a:latin typeface="Arial"/>
                          <a:cs typeface="Arial"/>
                        </a:rPr>
                        <a:t>7.601e-07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.54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6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041022" y="570910"/>
            <a:ext cx="6062511" cy="636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800" dirty="0" smtClean="0">
                <a:latin typeface="Arial"/>
                <a:cs typeface="Arial"/>
              </a:rPr>
              <a:t>Supplementary </a:t>
            </a:r>
            <a:r>
              <a:rPr lang="en-US" sz="800" dirty="0">
                <a:latin typeface="Arial"/>
                <a:cs typeface="Arial"/>
              </a:rPr>
              <a:t>Table </a:t>
            </a:r>
            <a:r>
              <a:rPr lang="en-US" sz="800" dirty="0" smtClean="0">
                <a:latin typeface="Arial"/>
                <a:cs typeface="Arial"/>
              </a:rPr>
              <a:t>4. Student’s </a:t>
            </a:r>
            <a:r>
              <a:rPr lang="en-US" sz="800" dirty="0">
                <a:latin typeface="Arial"/>
                <a:cs typeface="Arial"/>
              </a:rPr>
              <a:t>t-tests performed to evaluate the significance of the correlations described </a:t>
            </a:r>
            <a:r>
              <a:rPr lang="en-US" sz="800" dirty="0" smtClean="0">
                <a:latin typeface="Arial"/>
                <a:cs typeface="Arial"/>
              </a:rPr>
              <a:t>in TARA </a:t>
            </a:r>
            <a:r>
              <a:rPr lang="en-US" sz="800" dirty="0">
                <a:latin typeface="Arial"/>
                <a:cs typeface="Arial"/>
              </a:rPr>
              <a:t>Oceans dataset analyses. </a:t>
            </a:r>
            <a:r>
              <a:rPr lang="en-US" sz="800" dirty="0" smtClean="0">
                <a:latin typeface="Arial"/>
                <a:cs typeface="Arial"/>
              </a:rPr>
              <a:t>The </a:t>
            </a:r>
            <a:r>
              <a:rPr lang="en-US" sz="800" dirty="0">
                <a:latin typeface="Arial"/>
                <a:cs typeface="Arial"/>
              </a:rPr>
              <a:t>taxonomic and functional richness and diversity were computed by </a:t>
            </a:r>
            <a:r>
              <a:rPr lang="en-US" sz="800" dirty="0" err="1">
                <a:latin typeface="Arial"/>
                <a:cs typeface="Arial"/>
              </a:rPr>
              <a:t>Sunagawa</a:t>
            </a:r>
            <a:r>
              <a:rPr lang="en-US" sz="800" dirty="0">
                <a:latin typeface="Arial"/>
                <a:cs typeface="Arial"/>
              </a:rPr>
              <a:t> et al. ODU: Operational Domain Units. </a:t>
            </a:r>
          </a:p>
        </p:txBody>
      </p:sp>
    </p:spTree>
    <p:extLst>
      <p:ext uri="{BB962C8B-B14F-4D97-AF65-F5344CB8AC3E}">
        <p14:creationId xmlns:p14="http://schemas.microsoft.com/office/powerpoint/2010/main" val="17121652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33469" y="465189"/>
            <a:ext cx="6263352" cy="820738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800" dirty="0">
                <a:latin typeface="Arial"/>
                <a:cs typeface="Arial"/>
              </a:rPr>
              <a:t>Supplementary Table 5. PERMANOVA to test if the predicted BGC class composition in the HMP metagenomes differs between body sites. The PERMANOVA was performed on the Bray-Curtis dissimilarity matrices obtained from the relative abundance of BGC classes, for a balanced subset of 216 metagenomes (i.e., 54 from each body site). P-values were adjusted with the </a:t>
            </a:r>
            <a:r>
              <a:rPr lang="en-US" sz="800" dirty="0" err="1">
                <a:latin typeface="Arial"/>
                <a:cs typeface="Arial"/>
              </a:rPr>
              <a:t>Bonferroni</a:t>
            </a:r>
            <a:r>
              <a:rPr lang="en-US" sz="800" dirty="0">
                <a:latin typeface="Arial"/>
                <a:cs typeface="Arial"/>
              </a:rPr>
              <a:t> correction for multiple comparisons. 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4391517"/>
              </p:ext>
            </p:extLst>
          </p:nvPr>
        </p:nvGraphicFramePr>
        <p:xfrm>
          <a:off x="833468" y="1331698"/>
          <a:ext cx="6263352" cy="347111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62823"/>
                <a:gridCol w="648492"/>
                <a:gridCol w="790728"/>
                <a:gridCol w="711655"/>
                <a:gridCol w="711655"/>
                <a:gridCol w="958334"/>
                <a:gridCol w="473484"/>
                <a:gridCol w="706181"/>
              </a:tblGrid>
              <a:tr h="363958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Compariso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-value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-value adjusted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Pseudo-F statistic</a:t>
                      </a:r>
                      <a:endParaRPr lang="en-US" sz="800" b="1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R</a:t>
                      </a:r>
                      <a:r>
                        <a:rPr lang="en-US" sz="800" b="1" baseline="300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# of</a:t>
                      </a:r>
                      <a:r>
                        <a:rPr lang="en-US" sz="800" b="1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perm.</a:t>
                      </a:r>
                      <a:endParaRPr lang="en-US" sz="800" b="1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N</a:t>
                      </a:r>
                      <a:endParaRPr lang="en-US" sz="800" b="1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Degrees</a:t>
                      </a:r>
                      <a:r>
                        <a:rPr lang="en-US" sz="800" b="1" baseline="0" dirty="0" smtClean="0">
                          <a:latin typeface="Arial"/>
                          <a:cs typeface="Arial"/>
                        </a:rPr>
                        <a:t> of freedom</a:t>
                      </a:r>
                      <a:endParaRPr lang="en-US" sz="800" b="1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395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All body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sit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NA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40.2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66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21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1364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Arial"/>
                          <a:cs typeface="Arial"/>
                        </a:rPr>
                        <a:t>Supragingiv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plaque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vs. </a:t>
                      </a:r>
                      <a:br>
                        <a:rPr lang="en-US" sz="800" dirty="0" smtClean="0">
                          <a:latin typeface="Arial"/>
                          <a:cs typeface="Arial"/>
                        </a:rPr>
                      </a:br>
                      <a:r>
                        <a:rPr lang="en-US" sz="800" dirty="0" smtClean="0">
                          <a:latin typeface="Arial"/>
                          <a:cs typeface="Arial"/>
                        </a:rPr>
                        <a:t>bucc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mucosa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46.6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 0.5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395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Arial"/>
                          <a:cs typeface="Arial"/>
                        </a:rPr>
                        <a:t>Supragingiv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plaque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vs. </a:t>
                      </a:r>
                      <a:br>
                        <a:rPr lang="en-US" sz="800" dirty="0" smtClean="0">
                          <a:latin typeface="Arial"/>
                          <a:cs typeface="Arial"/>
                        </a:rPr>
                      </a:br>
                      <a:r>
                        <a:rPr lang="en-US" sz="800" dirty="0" smtClean="0">
                          <a:latin typeface="Arial"/>
                          <a:cs typeface="Arial"/>
                        </a:rPr>
                        <a:t>tongue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dors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57.3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 0.3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395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Arial"/>
                          <a:cs typeface="Arial"/>
                        </a:rPr>
                        <a:t>Supragingiv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plaque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vs. </a:t>
                      </a:r>
                      <a:br>
                        <a:rPr lang="en-US" sz="800" dirty="0" smtClean="0">
                          <a:latin typeface="Arial"/>
                          <a:cs typeface="Arial"/>
                        </a:rPr>
                      </a:br>
                      <a:r>
                        <a:rPr lang="en-US" sz="800" dirty="0" smtClean="0">
                          <a:latin typeface="Arial"/>
                          <a:cs typeface="Arial"/>
                        </a:rPr>
                        <a:t>stoo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324.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7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3958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Bucc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mucosa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vs. </a:t>
                      </a:r>
                      <a:br>
                        <a:rPr lang="en-US" sz="800" dirty="0" smtClean="0">
                          <a:latin typeface="Arial"/>
                          <a:cs typeface="Arial"/>
                        </a:rPr>
                      </a:br>
                      <a:r>
                        <a:rPr lang="en-US" sz="800" dirty="0" smtClean="0">
                          <a:latin typeface="Arial"/>
                          <a:cs typeface="Arial"/>
                        </a:rPr>
                        <a:t>tongue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dors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45.2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3958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Bucc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mucosa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vs. </a:t>
                      </a:r>
                      <a:br>
                        <a:rPr lang="en-US" sz="800" dirty="0" smtClean="0">
                          <a:latin typeface="Arial"/>
                          <a:cs typeface="Arial"/>
                        </a:rPr>
                      </a:br>
                      <a:r>
                        <a:rPr lang="en-US" sz="800" dirty="0" smtClean="0">
                          <a:latin typeface="Arial"/>
                          <a:cs typeface="Arial"/>
                        </a:rPr>
                        <a:t>stoo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 134.6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5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3958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Tongue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dorsum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vs.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/>
                          <a:cs typeface="Arial"/>
                        </a:rPr>
                        <a:t>stoo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00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92.1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0.6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99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459966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76369" y="814955"/>
            <a:ext cx="6756397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800" dirty="0">
                <a:latin typeface="Arial"/>
                <a:cs typeface="Arial"/>
              </a:rPr>
              <a:t>Supplementary Table 6</a:t>
            </a:r>
            <a:r>
              <a:rPr lang="en-US" sz="800" dirty="0" smtClean="0">
                <a:latin typeface="Arial"/>
                <a:cs typeface="Arial"/>
              </a:rPr>
              <a:t>. Wilcoxon </a:t>
            </a:r>
            <a:r>
              <a:rPr lang="en-US" sz="800" dirty="0">
                <a:latin typeface="Arial"/>
                <a:cs typeface="Arial"/>
              </a:rPr>
              <a:t>rank sum tests (two-sided</a:t>
            </a:r>
            <a:r>
              <a:rPr lang="en-US" sz="800" dirty="0" smtClean="0">
                <a:latin typeface="Arial"/>
                <a:cs typeface="Arial"/>
              </a:rPr>
              <a:t>) </a:t>
            </a:r>
            <a:r>
              <a:rPr lang="en-US" sz="800" dirty="0">
                <a:latin typeface="Arial"/>
                <a:cs typeface="Arial"/>
              </a:rPr>
              <a:t>performed </a:t>
            </a:r>
            <a:r>
              <a:rPr lang="en-US" sz="800" dirty="0" smtClean="0">
                <a:latin typeface="Arial"/>
                <a:cs typeface="Arial"/>
              </a:rPr>
              <a:t>to </a:t>
            </a:r>
            <a:r>
              <a:rPr lang="en-US" sz="800" dirty="0">
                <a:latin typeface="Arial"/>
                <a:cs typeface="Arial"/>
              </a:rPr>
              <a:t>evaluate the significance of the differentiation between the </a:t>
            </a:r>
            <a:r>
              <a:rPr lang="en-US" sz="800" dirty="0" err="1">
                <a:latin typeface="Arial"/>
                <a:cs typeface="Arial"/>
              </a:rPr>
              <a:t>supragingival</a:t>
            </a:r>
            <a:r>
              <a:rPr lang="en-US" sz="800" dirty="0">
                <a:latin typeface="Arial"/>
                <a:cs typeface="Arial"/>
              </a:rPr>
              <a:t> plaque, and the buccal mucosa, tongue dorsum and stool body sites, according to the Operational Domain Unit (ODU) diversity.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4081602"/>
              </p:ext>
            </p:extLst>
          </p:nvPr>
        </p:nvGraphicFramePr>
        <p:xfrm>
          <a:off x="1176369" y="1266361"/>
          <a:ext cx="6756397" cy="309257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71133"/>
                <a:gridCol w="1482165"/>
                <a:gridCol w="922866"/>
                <a:gridCol w="812800"/>
                <a:gridCol w="838200"/>
                <a:gridCol w="829233"/>
              </a:tblGrid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Compariso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/>
                          <a:cs typeface="Arial"/>
                        </a:rPr>
                        <a:t>Pairwi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-value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baseline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tatistic</a:t>
                      </a:r>
                      <a:endParaRPr lang="en-US" sz="800" b="1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Arial"/>
                          <a:cs typeface="Arial"/>
                        </a:rPr>
                        <a:t>Supragingiv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plaque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vs.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bucc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mucosa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 (54 + 54)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.769e-1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484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Arial"/>
                          <a:cs typeface="Arial"/>
                        </a:rPr>
                        <a:t>Supragingiv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plaque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tongue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dors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 (54 + 54)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4.649e-09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423.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AMP-binding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Arial"/>
                          <a:cs typeface="Arial"/>
                        </a:rPr>
                        <a:t>Supragingiv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plaque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vs.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stoo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 (54 + 54)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4.81e-1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46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Arial"/>
                          <a:cs typeface="Arial"/>
                        </a:rPr>
                        <a:t>Supragingiv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plaque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vs.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bucc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mucosa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 (54 + 54)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.672e-1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485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Arial"/>
                          <a:cs typeface="Arial"/>
                        </a:rPr>
                        <a:t>Supragingiv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plaque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vs.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tongue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dors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 (54 + 54)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.871e-1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483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49376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/>
                          <a:cs typeface="Arial"/>
                        </a:rPr>
                        <a:t>Condensation ODU</a:t>
                      </a:r>
                      <a:r>
                        <a:rPr lang="en-US" sz="800" b="0" baseline="0" dirty="0" smtClean="0">
                          <a:latin typeface="Arial"/>
                          <a:cs typeface="Arial"/>
                        </a:rPr>
                        <a:t> alpha diversity</a:t>
                      </a:r>
                      <a:endParaRPr lang="en-US" sz="800" b="0" dirty="0" smtClean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Arial"/>
                          <a:cs typeface="Arial"/>
                        </a:rPr>
                        <a:t>Supragingival</a:t>
                      </a:r>
                      <a:r>
                        <a:rPr lang="en-US" sz="80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Arial"/>
                          <a:cs typeface="Arial"/>
                        </a:rPr>
                        <a:t>plaque 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vs.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stoo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Yes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08 (54 + 54)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2.767e-10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/>
                          <a:cs typeface="Arial"/>
                        </a:rPr>
                        <a:t>1476</a:t>
                      </a:r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203337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8174437"/>
              </p:ext>
            </p:extLst>
          </p:nvPr>
        </p:nvGraphicFramePr>
        <p:xfrm>
          <a:off x="2043953" y="1379678"/>
          <a:ext cx="4572000" cy="1752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01520"/>
                <a:gridCol w="1285240"/>
                <a:gridCol w="1285240"/>
              </a:tblGrid>
              <a:tr h="29210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TARA Oceans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HMP </a:t>
                      </a:r>
                      <a:endParaRPr lang="en-US" sz="80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9210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#</a:t>
                      </a:r>
                      <a:r>
                        <a:rPr lang="en-US" sz="800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 metagenomes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139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91</a:t>
                      </a:r>
                      <a:endParaRPr lang="en-US" sz="80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9210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# </a:t>
                      </a:r>
                      <a:r>
                        <a:rPr lang="en-US" sz="80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of 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read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51,220,320,380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33,893,000,957</a:t>
                      </a:r>
                      <a:endParaRPr lang="en-US" sz="80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9210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# of HQ sequence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25,458,208,43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6,997,667,248</a:t>
                      </a:r>
                      <a:endParaRPr lang="en-US" sz="80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9210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# of ORFs predicted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23,281,706,61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3,184,977,62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210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# </a:t>
                      </a:r>
                      <a:r>
                        <a:rPr lang="en-US" sz="80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of annotated BGC domains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260,490,101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35,798,41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2043953" y="1164234"/>
            <a:ext cx="45720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Supplementary Table 7</a:t>
            </a:r>
            <a:r>
              <a:rPr lang="en-US" sz="800" dirty="0" smtClean="0">
                <a:latin typeface="Arial"/>
                <a:cs typeface="Arial"/>
              </a:rPr>
              <a:t>. </a:t>
            </a:r>
            <a:r>
              <a:rPr lang="en-US" sz="800" dirty="0">
                <a:latin typeface="Arial"/>
                <a:cs typeface="Arial"/>
              </a:rPr>
              <a:t>Details of the TARA Oceans and HMP </a:t>
            </a:r>
            <a:r>
              <a:rPr lang="en-US" sz="800" dirty="0" err="1" smtClean="0">
                <a:latin typeface="Arial"/>
                <a:cs typeface="Arial"/>
              </a:rPr>
              <a:t>analysed</a:t>
            </a:r>
            <a:r>
              <a:rPr lang="en-US" sz="800" dirty="0" smtClean="0">
                <a:latin typeface="Arial"/>
                <a:cs typeface="Arial"/>
              </a:rPr>
              <a:t> </a:t>
            </a:r>
            <a:r>
              <a:rPr lang="en-US" sz="800" dirty="0">
                <a:latin typeface="Arial"/>
                <a:cs typeface="Arial"/>
              </a:rPr>
              <a:t>metagenomes.</a:t>
            </a:r>
          </a:p>
        </p:txBody>
      </p:sp>
    </p:spTree>
    <p:extLst>
      <p:ext uri="{BB962C8B-B14F-4D97-AF65-F5344CB8AC3E}">
        <p14:creationId xmlns:p14="http://schemas.microsoft.com/office/powerpoint/2010/main" val="37692302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122244" y="956835"/>
            <a:ext cx="5130301" cy="6360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800" dirty="0">
                <a:latin typeface="Arial"/>
                <a:cs typeface="Arial"/>
              </a:rPr>
              <a:t>Supplementary Table </a:t>
            </a:r>
            <a:r>
              <a:rPr lang="en-US" sz="800" dirty="0" smtClean="0">
                <a:latin typeface="Arial"/>
                <a:cs typeface="Arial"/>
              </a:rPr>
              <a:t>8. </a:t>
            </a:r>
            <a:r>
              <a:rPr lang="en-US" sz="800" dirty="0">
                <a:latin typeface="Arial"/>
                <a:cs typeface="Arial"/>
              </a:rPr>
              <a:t>Details of the nine TARA Oceans metagenomes used in the evaluation of </a:t>
            </a:r>
            <a:r>
              <a:rPr lang="en-US" sz="800" dirty="0" err="1">
                <a:latin typeface="Arial"/>
                <a:cs typeface="Arial"/>
              </a:rPr>
              <a:t>BiG-MEx</a:t>
            </a:r>
            <a:r>
              <a:rPr lang="en-US" sz="800" dirty="0">
                <a:latin typeface="Arial"/>
                <a:cs typeface="Arial"/>
              </a:rPr>
              <a:t> BGC domain identification module. SRF, DCM, and MES abbreviations correspond to surface, deep chlorophyll maximum and mesopelagic water layers, respectively.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5555976"/>
              </p:ext>
            </p:extLst>
          </p:nvPr>
        </p:nvGraphicFramePr>
        <p:xfrm>
          <a:off x="2122243" y="1599222"/>
          <a:ext cx="5130303" cy="24712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17092"/>
                <a:gridCol w="735028"/>
                <a:gridCol w="1026061"/>
                <a:gridCol w="1026061"/>
                <a:gridCol w="1026061"/>
              </a:tblGrid>
              <a:tr h="33053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Sample name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Water layer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# PE reads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US" sz="800" dirty="0" smtClean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# QC sequences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endParaRPr lang="en-US" sz="800" dirty="0" smtClean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US" sz="800" dirty="0" smtClean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# ORFs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339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TARA_004_SRF_0.22-1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SRF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404,962,514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19,479,553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03,123,857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2339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TARA_007_SRF_0.22-1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SRF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21,166,612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38,645,938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19,212,194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2339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TARA_009_SRF_0.22-1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SRF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489,617,426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32,980,853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10,248,922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2339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TARA_004_DCM_0.22-1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DCM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476,921,334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20,441,035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02,942,150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2339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TARA_007_DCM_0.22-1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DCM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78,519,830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07,088,525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96,658,295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2339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TARA_009_DCM_0.22-1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DCM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416,553,274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17,526,916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02,183,924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2339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TARA_037_MES_0.22-1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MES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399,390,808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93,596,707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79,380,880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2339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TARA_038_MES_0.22-1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MES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/>
                          <a:ea typeface="Times New Roman"/>
                          <a:cs typeface="Arial"/>
                        </a:rPr>
                        <a:t>260,588,896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39,878,638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26,264,027</a:t>
                      </a: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</a:tr>
              <a:tr h="2339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TARA_039_MES_0.22-1</a:t>
                      </a:r>
                    </a:p>
                  </a:txBody>
                  <a:tcPr marL="68580" marR="68580" marT="0" marB="0" anchor="ctr"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MES</a:t>
                      </a:r>
                    </a:p>
                  </a:txBody>
                  <a:tcPr marL="68580" marR="68580" marT="0" marB="0" anchor="ctr"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277,574,946</a:t>
                      </a:r>
                    </a:p>
                  </a:txBody>
                  <a:tcPr marL="68580" marR="68580" marT="0" marB="0" anchor="ctr"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37,114,641</a:t>
                      </a:r>
                    </a:p>
                  </a:txBody>
                  <a:tcPr marL="68580" marR="68580" marT="0" marB="0" anchor="ctr"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/>
                          <a:ea typeface="Times New Roman"/>
                          <a:cs typeface="Arial"/>
                        </a:rPr>
                        <a:t>124,762,241</a:t>
                      </a:r>
                    </a:p>
                  </a:txBody>
                  <a:tcPr marL="68580" marR="68580" marT="0" marB="0" anchor="ctr">
                    <a:lnB w="12700" cap="flat" cmpd="sng" algn="ctr">
                      <a:solidFill>
                        <a:prstClr val="black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418638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841350" y="884892"/>
            <a:ext cx="4196537" cy="4514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800" dirty="0" smtClean="0">
                <a:latin typeface="Arial"/>
                <a:cs typeface="Arial"/>
              </a:rPr>
              <a:t>Supplementary Table </a:t>
            </a:r>
            <a:r>
              <a:rPr lang="en-US" sz="800" dirty="0">
                <a:latin typeface="Arial"/>
                <a:cs typeface="Arial"/>
              </a:rPr>
              <a:t>9</a:t>
            </a:r>
            <a:r>
              <a:rPr lang="en-US" sz="800" dirty="0" smtClean="0">
                <a:latin typeface="Arial"/>
                <a:cs typeface="Arial"/>
              </a:rPr>
              <a:t>. Details of the assembled </a:t>
            </a:r>
            <a:r>
              <a:rPr lang="en-US" sz="800" dirty="0">
                <a:latin typeface="Arial"/>
                <a:cs typeface="Arial"/>
              </a:rPr>
              <a:t>metagenomes of the </a:t>
            </a:r>
            <a:r>
              <a:rPr lang="en-US" sz="800" dirty="0" smtClean="0">
                <a:latin typeface="Arial"/>
                <a:cs typeface="Arial"/>
              </a:rPr>
              <a:t>Marine-TM dataset.</a:t>
            </a:r>
            <a:endParaRPr lang="en-US" sz="800" i="1" dirty="0">
              <a:latin typeface="Arial"/>
              <a:cs typeface="Arial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3122442"/>
              </p:ext>
            </p:extLst>
          </p:nvPr>
        </p:nvGraphicFramePr>
        <p:xfrm>
          <a:off x="1841350" y="1336298"/>
          <a:ext cx="4196537" cy="1356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92645"/>
                <a:gridCol w="1903892"/>
              </a:tblGrid>
              <a:tr h="22606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# </a:t>
                      </a:r>
                      <a:r>
                        <a:rPr lang="en-US" sz="8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of</a:t>
                      </a:r>
                      <a:r>
                        <a:rPr lang="en-US" sz="800" b="0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 assembled</a:t>
                      </a:r>
                      <a:r>
                        <a:rPr lang="en-US" sz="8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 </a:t>
                      </a: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metagenomes</a:t>
                      </a:r>
                      <a:endParaRPr lang="en-US" sz="800" b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50</a:t>
                      </a:r>
                      <a:endParaRPr lang="en-US" sz="800" b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606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# of PE read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200.000.000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606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</a:rPr>
                        <a:t># of contigs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</a:rPr>
                        <a:t>4,479,15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606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Average N50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  <a:cs typeface="Arial"/>
                        </a:rPr>
                        <a:t>755.52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606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</a:rPr>
                        <a:t># of contigs annotated with a BGC domain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</a:rPr>
                        <a:t>749,575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606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</a:rPr>
                        <a:t># of contigs annotated with a BGC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</a:rPr>
                        <a:t>class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</a:rPr>
                        <a:t>465 (0.06%</a:t>
                      </a: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/>
                        </a:rPr>
                        <a:t>)*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1821030" y="2699524"/>
            <a:ext cx="421685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 *Percentage of contigs annotated with a BGC </a:t>
            </a:r>
            <a:r>
              <a:rPr lang="en-US" sz="800" dirty="0" smtClean="0">
                <a:latin typeface="Arial"/>
                <a:cs typeface="Arial"/>
              </a:rPr>
              <a:t>class </a:t>
            </a:r>
            <a:r>
              <a:rPr lang="en-US" sz="800" dirty="0">
                <a:latin typeface="Arial"/>
                <a:cs typeface="Arial"/>
              </a:rPr>
              <a:t>taking the contigs annotated with a BGC domain as the total.</a:t>
            </a:r>
          </a:p>
        </p:txBody>
      </p:sp>
    </p:spTree>
    <p:extLst>
      <p:ext uri="{BB962C8B-B14F-4D97-AF65-F5344CB8AC3E}">
        <p14:creationId xmlns:p14="http://schemas.microsoft.com/office/powerpoint/2010/main" val="4179494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22</TotalTime>
  <Words>1439</Words>
  <Application>Microsoft Macintosh PowerPoint</Application>
  <PresentationFormat>On-screen Show (4:3)</PresentationFormat>
  <Paragraphs>462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P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iano Pereira</dc:creator>
  <cp:lastModifiedBy>Emiliano Pereira</cp:lastModifiedBy>
  <cp:revision>182</cp:revision>
  <dcterms:created xsi:type="dcterms:W3CDTF">2018-07-16T13:01:13Z</dcterms:created>
  <dcterms:modified xsi:type="dcterms:W3CDTF">2019-04-21T19:37:20Z</dcterms:modified>
</cp:coreProperties>
</file>